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598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D21-4165-8639-653512B3E3DF}"/>
              </c:ext>
            </c:extLst>
          </c:dPt>
          <c:dPt>
            <c:idx val="1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D21-4165-8639-653512B3E3DF}"/>
              </c:ext>
            </c:extLst>
          </c:dPt>
          <c:dPt>
            <c:idx val="2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D21-4165-8639-653512B3E3DF}"/>
              </c:ext>
            </c:extLst>
          </c:dPt>
          <c:dPt>
            <c:idx val="3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3D21-4165-8639-653512B3E3DF}"/>
              </c:ext>
            </c:extLst>
          </c:dPt>
          <c:dPt>
            <c:idx val="4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3D21-4165-8639-653512B3E3DF}"/>
              </c:ext>
            </c:extLst>
          </c:dPt>
          <c:dPt>
            <c:idx val="5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3D21-4165-8639-653512B3E3DF}"/>
              </c:ext>
            </c:extLst>
          </c:dPt>
          <c:dPt>
            <c:idx val="6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3D21-4165-8639-653512B3E3DF}"/>
              </c:ext>
            </c:extLst>
          </c:dPt>
          <c:dPt>
            <c:idx val="7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3D21-4165-8639-653512B3E3DF}"/>
              </c:ext>
            </c:extLst>
          </c:dPt>
          <c:dPt>
            <c:idx val="8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3D21-4165-8639-653512B3E3DF}"/>
              </c:ext>
            </c:extLst>
          </c:dPt>
          <c:dPt>
            <c:idx val="9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3D21-4165-8639-653512B3E3DF}"/>
              </c:ext>
            </c:extLst>
          </c:dPt>
          <c:dPt>
            <c:idx val="10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3D21-4165-8639-653512B3E3DF}"/>
              </c:ext>
            </c:extLst>
          </c:dPt>
          <c:dPt>
            <c:idx val="11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3D21-4165-8639-653512B3E3DF}"/>
              </c:ext>
            </c:extLst>
          </c:dPt>
          <c:dPt>
            <c:idx val="12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3D21-4165-8639-653512B3E3DF}"/>
              </c:ext>
            </c:extLst>
          </c:dPt>
          <c:dPt>
            <c:idx val="13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3D21-4165-8639-653512B3E3DF}"/>
              </c:ext>
            </c:extLst>
          </c:dPt>
          <c:dPt>
            <c:idx val="14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3D21-4165-8639-653512B3E3DF}"/>
              </c:ext>
            </c:extLst>
          </c:dPt>
          <c:dPt>
            <c:idx val="15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3D21-4165-8639-653512B3E3DF}"/>
              </c:ext>
            </c:extLst>
          </c:dPt>
          <c:dPt>
            <c:idx val="16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3D21-4165-8639-653512B3E3DF}"/>
              </c:ext>
            </c:extLst>
          </c:dPt>
          <c:dPt>
            <c:idx val="17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3D21-4165-8639-653512B3E3DF}"/>
              </c:ext>
            </c:extLst>
          </c:dPt>
          <c:dPt>
            <c:idx val="18"/>
            <c:invertIfNegative val="0"/>
            <c:bubble3D val="0"/>
            <c:spPr>
              <a:solidFill>
                <a:srgbClr val="FB6542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3D21-4165-8639-653512B3E3DF}"/>
              </c:ext>
            </c:extLst>
          </c:dPt>
          <c:dPt>
            <c:idx val="19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3D21-4165-8639-653512B3E3DF}"/>
              </c:ext>
            </c:extLst>
          </c:dPt>
          <c:dPt>
            <c:idx val="21"/>
            <c:invertIfNegative val="0"/>
            <c:bubble3D val="0"/>
            <c:spPr>
              <a:solidFill>
                <a:srgbClr val="375E97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3D21-4165-8639-653512B3E3DF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R$18:$R$39</c:f>
                <c:numCache>
                  <c:formatCode>General</c:formatCode>
                  <c:ptCount val="22"/>
                  <c:pt idx="0">
                    <c:v>0.29837453325354202</c:v>
                  </c:pt>
                  <c:pt idx="1">
                    <c:v>0.10137561044143183</c:v>
                  </c:pt>
                  <c:pt idx="2">
                    <c:v>0.38135315595506403</c:v>
                  </c:pt>
                  <c:pt idx="3">
                    <c:v>0.7405299296815715</c:v>
                  </c:pt>
                  <c:pt idx="4">
                    <c:v>0.18067615586199501</c:v>
                  </c:pt>
                  <c:pt idx="5">
                    <c:v>0.10857466303146703</c:v>
                  </c:pt>
                  <c:pt idx="6">
                    <c:v>0.29983263446945702</c:v>
                  </c:pt>
                  <c:pt idx="7">
                    <c:v>0.39132085876956446</c:v>
                  </c:pt>
                  <c:pt idx="8">
                    <c:v>0.32808519752258503</c:v>
                  </c:pt>
                  <c:pt idx="9">
                    <c:v>0.30649007281269319</c:v>
                  </c:pt>
                  <c:pt idx="10">
                    <c:v>0.25717399371918997</c:v>
                  </c:pt>
                  <c:pt idx="11">
                    <c:v>0.44984238976015722</c:v>
                  </c:pt>
                  <c:pt idx="12">
                    <c:v>0.200696551758725</c:v>
                  </c:pt>
                  <c:pt idx="13">
                    <c:v>0.14275999660358527</c:v>
                  </c:pt>
                  <c:pt idx="14">
                    <c:v>0.11097372018778</c:v>
                  </c:pt>
                  <c:pt idx="15">
                    <c:v>0.12394463063204546</c:v>
                  </c:pt>
                  <c:pt idx="16">
                    <c:v>0.40657911009185899</c:v>
                  </c:pt>
                  <c:pt idx="17">
                    <c:v>0.4492407353495701</c:v>
                  </c:pt>
                  <c:pt idx="18">
                    <c:v>0.19745514147541299</c:v>
                  </c:pt>
                  <c:pt idx="19">
                    <c:v>0.16049011292304391</c:v>
                  </c:pt>
                  <c:pt idx="21">
                    <c:v>5.5854018615653575E-2</c:v>
                  </c:pt>
                </c:numCache>
              </c:numRef>
            </c:plus>
            <c:minus>
              <c:numRef>
                <c:f>Tabelle1!$R$18:$R$39</c:f>
                <c:numCache>
                  <c:formatCode>General</c:formatCode>
                  <c:ptCount val="22"/>
                  <c:pt idx="0">
                    <c:v>0.29837453325354202</c:v>
                  </c:pt>
                  <c:pt idx="1">
                    <c:v>0.10137561044143183</c:v>
                  </c:pt>
                  <c:pt idx="2">
                    <c:v>0.38135315595506403</c:v>
                  </c:pt>
                  <c:pt idx="3">
                    <c:v>0.7405299296815715</c:v>
                  </c:pt>
                  <c:pt idx="4">
                    <c:v>0.18067615586199501</c:v>
                  </c:pt>
                  <c:pt idx="5">
                    <c:v>0.10857466303146703</c:v>
                  </c:pt>
                  <c:pt idx="6">
                    <c:v>0.29983263446945702</c:v>
                  </c:pt>
                  <c:pt idx="7">
                    <c:v>0.39132085876956446</c:v>
                  </c:pt>
                  <c:pt idx="8">
                    <c:v>0.32808519752258503</c:v>
                  </c:pt>
                  <c:pt idx="9">
                    <c:v>0.30649007281269319</c:v>
                  </c:pt>
                  <c:pt idx="10">
                    <c:v>0.25717399371918997</c:v>
                  </c:pt>
                  <c:pt idx="11">
                    <c:v>0.44984238976015722</c:v>
                  </c:pt>
                  <c:pt idx="12">
                    <c:v>0.200696551758725</c:v>
                  </c:pt>
                  <c:pt idx="13">
                    <c:v>0.14275999660358527</c:v>
                  </c:pt>
                  <c:pt idx="14">
                    <c:v>0.11097372018778</c:v>
                  </c:pt>
                  <c:pt idx="15">
                    <c:v>0.12394463063204546</c:v>
                  </c:pt>
                  <c:pt idx="16">
                    <c:v>0.40657911009185899</c:v>
                  </c:pt>
                  <c:pt idx="17">
                    <c:v>0.4492407353495701</c:v>
                  </c:pt>
                  <c:pt idx="18">
                    <c:v>0.19745514147541299</c:v>
                  </c:pt>
                  <c:pt idx="19">
                    <c:v>0.16049011292304391</c:v>
                  </c:pt>
                  <c:pt idx="21">
                    <c:v>5.58540186156535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P$18:$P$39</c:f>
              <c:strCache>
                <c:ptCount val="21"/>
                <c:pt idx="0">
                  <c:v>AT5G02520 </c:v>
                </c:pt>
                <c:pt idx="2">
                  <c:v>AT5G48560</c:v>
                </c:pt>
                <c:pt idx="4">
                  <c:v>AT2G01860</c:v>
                </c:pt>
                <c:pt idx="6">
                  <c:v>AT3G23110</c:v>
                </c:pt>
                <c:pt idx="8">
                  <c:v>AT2G40080</c:v>
                </c:pt>
                <c:pt idx="10">
                  <c:v>AT5G37770</c:v>
                </c:pt>
                <c:pt idx="12">
                  <c:v>AT1G10120</c:v>
                </c:pt>
                <c:pt idx="14">
                  <c:v>AT5G13690</c:v>
                </c:pt>
                <c:pt idx="16">
                  <c:v>AT1G02580</c:v>
                </c:pt>
                <c:pt idx="18">
                  <c:v>AT5G23940</c:v>
                </c:pt>
                <c:pt idx="20">
                  <c:v>AT1G01370</c:v>
                </c:pt>
              </c:strCache>
            </c:strRef>
          </c:cat>
          <c:val>
            <c:numRef>
              <c:f>Tabelle1!$Q$18:$Q$39</c:f>
              <c:numCache>
                <c:formatCode>General</c:formatCode>
                <c:ptCount val="22"/>
                <c:pt idx="0">
                  <c:v>-4.57490900825817</c:v>
                </c:pt>
                <c:pt idx="1">
                  <c:v>-5.9482610414623265</c:v>
                </c:pt>
                <c:pt idx="2">
                  <c:v>1.5443012847784101</c:v>
                </c:pt>
                <c:pt idx="3">
                  <c:v>1.7301065935151618</c:v>
                </c:pt>
                <c:pt idx="4">
                  <c:v>1.3953231496699401</c:v>
                </c:pt>
                <c:pt idx="5">
                  <c:v>1.4417335461862018</c:v>
                </c:pt>
                <c:pt idx="6">
                  <c:v>1.7764795482157401</c:v>
                </c:pt>
                <c:pt idx="7">
                  <c:v>1.7780958319347386</c:v>
                </c:pt>
                <c:pt idx="8">
                  <c:v>1.29665312149957</c:v>
                </c:pt>
                <c:pt idx="9">
                  <c:v>1.3441192237518182</c:v>
                </c:pt>
                <c:pt idx="10">
                  <c:v>1.8817816436296899</c:v>
                </c:pt>
                <c:pt idx="11">
                  <c:v>1.7207144705445538</c:v>
                </c:pt>
                <c:pt idx="12">
                  <c:v>0.70315530819408001</c:v>
                </c:pt>
                <c:pt idx="13">
                  <c:v>0.62031376568257213</c:v>
                </c:pt>
                <c:pt idx="14">
                  <c:v>-0.77338972446702603</c:v>
                </c:pt>
                <c:pt idx="15">
                  <c:v>-0.51152938821512828</c:v>
                </c:pt>
                <c:pt idx="16">
                  <c:v>1.8651202432341001</c:v>
                </c:pt>
                <c:pt idx="17">
                  <c:v>1.927770231366041</c:v>
                </c:pt>
                <c:pt idx="18">
                  <c:v>-0.804846828966577</c:v>
                </c:pt>
                <c:pt idx="19">
                  <c:v>-0.88114024445268468</c:v>
                </c:pt>
                <c:pt idx="21">
                  <c:v>-0.784506654523026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A-3D21-4165-8639-653512B3E3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4"/>
        <c:overlap val="4"/>
        <c:axId val="56799232"/>
        <c:axId val="56800768"/>
      </c:barChart>
      <c:catAx>
        <c:axId val="56799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solidFill>
            <a:schemeClr val="bg1"/>
          </a:solidFill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b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00768"/>
        <c:crosses val="autoZero"/>
        <c:auto val="0"/>
        <c:lblAlgn val="ctr"/>
        <c:lblOffset val="100"/>
        <c:noMultiLvlLbl val="0"/>
      </c:catAx>
      <c:valAx>
        <c:axId val="5680076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56799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838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95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5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12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411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05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18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437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251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888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05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496F0-DE22-4B27-939D-61F6E6D3761F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D5D037-9226-4F05-B6F3-0A846FA7EB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416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3072" y="929311"/>
            <a:ext cx="6464191" cy="3979867"/>
            <a:chOff x="23072" y="297803"/>
            <a:chExt cx="6464191" cy="3979867"/>
          </a:xfrm>
        </p:grpSpPr>
        <p:grpSp>
          <p:nvGrpSpPr>
            <p:cNvPr id="5" name="Gruppieren 4"/>
            <p:cNvGrpSpPr/>
            <p:nvPr/>
          </p:nvGrpSpPr>
          <p:grpSpPr>
            <a:xfrm>
              <a:off x="1441214" y="297803"/>
              <a:ext cx="5046049" cy="3979867"/>
              <a:chOff x="1327718" y="-196456"/>
              <a:chExt cx="8970752" cy="7075321"/>
            </a:xfrm>
          </p:grpSpPr>
          <p:sp>
            <p:nvSpPr>
              <p:cNvPr id="6" name="Textfeld 5"/>
              <p:cNvSpPr txBox="1"/>
              <p:nvPr/>
            </p:nvSpPr>
            <p:spPr>
              <a:xfrm>
                <a:off x="1596813" y="-196456"/>
                <a:ext cx="510796" cy="54305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2081"/>
                  </a:lnSpc>
                </a:pPr>
                <a:endParaRPr lang="de-DE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2081"/>
                  </a:lnSpc>
                </a:pPr>
                <a:endParaRPr lang="de-DE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3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  <a:p>
                <a:pPr algn="r">
                  <a:lnSpc>
                    <a:spcPts val="2081"/>
                  </a:lnSpc>
                </a:pP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6</a:t>
                </a:r>
              </a:p>
            </p:txBody>
          </p:sp>
          <p:sp>
            <p:nvSpPr>
              <p:cNvPr id="7" name="Textfeld 6"/>
              <p:cNvSpPr txBox="1"/>
              <p:nvPr/>
            </p:nvSpPr>
            <p:spPr>
              <a:xfrm rot="16200000">
                <a:off x="1193492" y="1880122"/>
                <a:ext cx="678820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de-DE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cxnSp>
            <p:nvCxnSpPr>
              <p:cNvPr id="8" name="Gerader Verbinder 17"/>
              <p:cNvCxnSpPr/>
              <p:nvPr/>
            </p:nvCxnSpPr>
            <p:spPr>
              <a:xfrm flipH="1">
                <a:off x="2080941" y="623489"/>
                <a:ext cx="5793" cy="466560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9" name="Diagramm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01883370"/>
                  </p:ext>
                </p:extLst>
              </p:nvPr>
            </p:nvGraphicFramePr>
            <p:xfrm>
              <a:off x="2087335" y="486137"/>
              <a:ext cx="8029179" cy="55211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0" name="Rechteck 9"/>
              <p:cNvSpPr/>
              <p:nvPr/>
            </p:nvSpPr>
            <p:spPr>
              <a:xfrm rot="16200000">
                <a:off x="5371379" y="1951773"/>
                <a:ext cx="1709616" cy="814456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ts val="1550"/>
                  </a:lnSpc>
                </a:pPr>
                <a:r>
                  <a:rPr lang="da-DK" sz="1013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5G02520</a:t>
                </a:r>
                <a:r>
                  <a:rPr lang="da-DK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da-DK" sz="1013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5G4856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2G0186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3G2311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2G4008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5G3777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1G1012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5G1369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1G0258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5G23940</a:t>
                </a:r>
              </a:p>
              <a:p>
                <a:pPr>
                  <a:lnSpc>
                    <a:spcPts val="1550"/>
                  </a:lnSpc>
                </a:pPr>
                <a:endParaRPr lang="da-DK" sz="101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550"/>
                  </a:lnSpc>
                </a:pPr>
                <a:r>
                  <a:rPr lang="da-DK" sz="1013" dirty="0">
                    <a:latin typeface="Arial" panose="020B0604020202020204" pitchFamily="34" charset="0"/>
                    <a:cs typeface="Arial" panose="020B0604020202020204" pitchFamily="34" charset="0"/>
                  </a:rPr>
                  <a:t>AT1G01370</a:t>
                </a:r>
              </a:p>
              <a:p>
                <a:pPr>
                  <a:lnSpc>
                    <a:spcPts val="1550"/>
                  </a:lnSpc>
                </a:pPr>
                <a:endParaRPr lang="da-DK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Gerader Verbinder 25"/>
              <p:cNvCxnSpPr/>
              <p:nvPr/>
            </p:nvCxnSpPr>
            <p:spPr>
              <a:xfrm flipV="1">
                <a:off x="2087335" y="623489"/>
                <a:ext cx="8107200" cy="3814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r Verbinder 29"/>
              <p:cNvCxnSpPr/>
              <p:nvPr/>
            </p:nvCxnSpPr>
            <p:spPr>
              <a:xfrm>
                <a:off x="2077685" y="5282258"/>
                <a:ext cx="8038829" cy="9305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Gerader Verbinder 30"/>
              <p:cNvCxnSpPr/>
              <p:nvPr/>
            </p:nvCxnSpPr>
            <p:spPr>
              <a:xfrm>
                <a:off x="2077684" y="1916854"/>
                <a:ext cx="8100001" cy="11769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Gerader Verbinder 31"/>
              <p:cNvCxnSpPr/>
              <p:nvPr/>
            </p:nvCxnSpPr>
            <p:spPr>
              <a:xfrm>
                <a:off x="2072094" y="5275503"/>
                <a:ext cx="8071200" cy="13586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r Verbinder 32"/>
              <p:cNvCxnSpPr/>
              <p:nvPr/>
            </p:nvCxnSpPr>
            <p:spPr>
              <a:xfrm flipH="1">
                <a:off x="2968884" y="623489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Gerader Verbinder 35"/>
              <p:cNvCxnSpPr/>
              <p:nvPr/>
            </p:nvCxnSpPr>
            <p:spPr>
              <a:xfrm flipH="1">
                <a:off x="10147144" y="629369"/>
                <a:ext cx="34724" cy="465840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Gerader Verbinder 36"/>
              <p:cNvCxnSpPr/>
              <p:nvPr/>
            </p:nvCxnSpPr>
            <p:spPr>
              <a:xfrm flipH="1">
                <a:off x="3648758" y="631108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Gerader Verbinder 37"/>
              <p:cNvCxnSpPr/>
              <p:nvPr/>
            </p:nvCxnSpPr>
            <p:spPr>
              <a:xfrm flipH="1">
                <a:off x="4335405" y="631108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Gerader Verbinder 38"/>
              <p:cNvCxnSpPr/>
              <p:nvPr/>
            </p:nvCxnSpPr>
            <p:spPr>
              <a:xfrm flipH="1">
                <a:off x="5023744" y="631108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Gerader Verbinder 39"/>
              <p:cNvCxnSpPr/>
              <p:nvPr/>
            </p:nvCxnSpPr>
            <p:spPr>
              <a:xfrm flipH="1">
                <a:off x="5718858" y="631109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Gerader Verbinder 40"/>
              <p:cNvCxnSpPr/>
              <p:nvPr/>
            </p:nvCxnSpPr>
            <p:spPr>
              <a:xfrm flipH="1">
                <a:off x="6427518" y="631109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Gerader Verbinder 41"/>
              <p:cNvCxnSpPr/>
              <p:nvPr/>
            </p:nvCxnSpPr>
            <p:spPr>
              <a:xfrm flipH="1">
                <a:off x="7115858" y="623489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r Verbinder 42"/>
              <p:cNvCxnSpPr/>
              <p:nvPr/>
            </p:nvCxnSpPr>
            <p:spPr>
              <a:xfrm flipH="1">
                <a:off x="7831291" y="631108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r Verbinder 43"/>
              <p:cNvCxnSpPr/>
              <p:nvPr/>
            </p:nvCxnSpPr>
            <p:spPr>
              <a:xfrm flipH="1">
                <a:off x="8490844" y="631108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Gerader Verbinder 44"/>
              <p:cNvCxnSpPr/>
              <p:nvPr/>
            </p:nvCxnSpPr>
            <p:spPr>
              <a:xfrm flipH="1">
                <a:off x="9269778" y="631109"/>
                <a:ext cx="34724" cy="465201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uppieren 25"/>
            <p:cNvGrpSpPr/>
            <p:nvPr/>
          </p:nvGrpSpPr>
          <p:grpSpPr>
            <a:xfrm>
              <a:off x="23072" y="858366"/>
              <a:ext cx="1688068" cy="406568"/>
              <a:chOff x="330578" y="1272540"/>
              <a:chExt cx="3001008" cy="722788"/>
            </a:xfrm>
          </p:grpSpPr>
          <p:sp>
            <p:nvSpPr>
              <p:cNvPr id="27" name="Rechteck 26"/>
              <p:cNvSpPr/>
              <p:nvPr/>
            </p:nvSpPr>
            <p:spPr>
              <a:xfrm>
                <a:off x="338198" y="1348740"/>
                <a:ext cx="195202" cy="182880"/>
              </a:xfrm>
              <a:prstGeom prst="rect">
                <a:avLst/>
              </a:prstGeom>
              <a:solidFill>
                <a:srgbClr val="FB654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13"/>
              </a:p>
            </p:txBody>
          </p:sp>
          <p:sp>
            <p:nvSpPr>
              <p:cNvPr id="28" name="Rechteck 27"/>
              <p:cNvSpPr/>
              <p:nvPr/>
            </p:nvSpPr>
            <p:spPr>
              <a:xfrm>
                <a:off x="330578" y="1686560"/>
                <a:ext cx="195202" cy="182880"/>
              </a:xfrm>
              <a:prstGeom prst="rect">
                <a:avLst/>
              </a:prstGeom>
              <a:solidFill>
                <a:srgbClr val="375E9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13"/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563879" y="1272540"/>
                <a:ext cx="2767707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NA-SEQ </a:t>
                </a:r>
                <a:r>
                  <a:rPr lang="de-D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  <a:endParaRPr lang="de-DE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563879" y="1584960"/>
                <a:ext cx="2608119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T-PCR </a:t>
                </a:r>
                <a:r>
                  <a:rPr lang="de-D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  <a:endParaRPr lang="de-DE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" name="Rechteck 2"/>
          <p:cNvSpPr/>
          <p:nvPr/>
        </p:nvSpPr>
        <p:spPr>
          <a:xfrm>
            <a:off x="116632" y="251520"/>
            <a:ext cx="2505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503175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Bildschirmpräsentation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na Lermontova</dc:creator>
  <cp:lastModifiedBy>Inna Lermontova</cp:lastModifiedBy>
  <cp:revision>8</cp:revision>
  <dcterms:created xsi:type="dcterms:W3CDTF">2019-03-28T12:46:13Z</dcterms:created>
  <dcterms:modified xsi:type="dcterms:W3CDTF">2019-10-29T13:38:26Z</dcterms:modified>
</cp:coreProperties>
</file>